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3197" autoAdjust="0"/>
  </p:normalViewPr>
  <p:slideViewPr>
    <p:cSldViewPr snapToGrid="0">
      <p:cViewPr varScale="1">
        <p:scale>
          <a:sx n="75" d="100"/>
          <a:sy n="75" d="100"/>
        </p:scale>
        <p:origin x="30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B78F49-F0D7-404E-BA0A-A4A193035E52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44E6E0-FF8B-4E52-BDA5-83F26C17D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988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ating strategy lymphedema flui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44E6E0-FF8B-4E52-BDA5-83F26C17DFA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5672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ating strategy bloo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D44E6E0-FF8B-4E52-BDA5-83F26C17DFA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8027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3A56D8-D21E-3E96-97C0-908267B2FF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E860DB-F87F-EE29-CB7A-64B795C734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0A0CF2-8B50-0CC9-9E02-307AC7DC2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60BB7F-C106-9A73-EB31-30F3A7BF5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9CF14A-C578-0B25-A975-5C80E4342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669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99E30-C634-EC1D-A184-D5338C37F7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F19256-CDF8-E31E-80D2-92DF66DC88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67BC2D-DDAE-666E-62E4-F9B6D484C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B99260-9994-E04D-90DE-7D7459E6B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5FBC9A-313B-69A5-26A7-79470EBCD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16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2A789A7-59F3-C021-DAB7-73FE484A07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014C80-4048-514D-5A03-F0F8DC85DC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17DE72-53FF-6359-CBC0-3D4E99EF3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B6343B-7B67-0BF6-97CE-6AD90DA6D6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22BD1D-50BF-0778-B2BE-77096BA5F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826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1AE68F-0ADF-C4D8-3161-07BD19020D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0975C6-8636-6DBC-9E00-E1E8764EFE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BA2A0B-D870-2706-D89E-CB1663B32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DABBD6-EBDE-5092-3DAD-F74B4B538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08BD3A-6294-00E5-3252-B18C3AF10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652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D5D20-3262-6666-5D2F-D15BB95CB9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2CF9CC-5A93-5D1A-F39F-A4A2831CE6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FD79C5-F9B0-3BA8-1F8C-DF44AF52E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FF272A-89A1-E7D8-A68A-5D6A10D3B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C63165-C8A4-5C7C-8BFF-7095DF8FA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463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B97D6B-F81D-F393-FB8F-4538DA15A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90FEEA-5557-7BE2-AFD7-5F90F12E2E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230581-2F2A-D578-5855-965516321E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B4FBE-6113-9698-C463-E2F3853ED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D6BE4D-AF9C-ED57-8177-ABC14BE5B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464528-DB16-2CB2-2C8C-230D4894C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421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B74F11-5E18-FF34-A8D7-252A653A3C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2178AB-9F2A-E203-456C-BC10D4CD06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DA3E73-30DA-8D6A-584C-E9C1EADF5F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1A5CD3-7D03-378A-101A-A742B797E8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4D5877A-22F7-9F7F-4770-9A1A3ABFB9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62A6F9-65F3-1AC7-2DA8-A66DBAF99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E76347-65E9-D0C8-4738-AF9E1AEF9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568D9D-5C62-6A0D-B439-4E3B7DEB7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922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55ECF0-BA37-5D60-421D-4B5FA176B0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B042EF0-F61B-6AB9-F96D-4398E4E8E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6EF1D0-03BD-0DC4-D29B-87FE1A6DF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10A4EC-7C9F-BD07-7B22-C7278D1F9C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268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20E5D43-EBBF-BDD6-0206-4A8C96328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C886B17-501C-B077-A16F-99519419E5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B1008F-3C3B-C549-2EEA-409F34DC9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474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4BDF87-8AF6-57CD-CF6D-FDE654EC72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BEAAE3-2F9B-8CF1-13FA-F1034E4C20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DBF182-269D-8E09-422A-E67340A07E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6C1585-2643-C3AB-1499-846CD7C0C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DB93B8-E328-AAD0-A563-C04C79797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1904A7-B1B9-48A2-E666-3B3D7B788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885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372098-E7E2-DEE9-18B5-506224F698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82500D-4F0F-11F0-1C6D-334666ECBF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A3BCF9-AEB5-A604-9FFB-B6C5E04698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245A40-7477-8091-1208-40243317D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BE7893-3AA7-0F14-73AC-509D3199F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BEC276-2F06-76F4-A221-FC1BE5F036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271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048042-D8B9-CD4D-F0C0-EA0F62700B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304CED-5468-660E-E851-59BDE55350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285834-D994-FA5E-6F3D-904DC313E0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DC0242-9847-4739-9593-75673CCC3C3F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D34A1-45EA-85AB-F40C-502358B624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0735EB-5C35-7E28-D16F-46EFE0E9D1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0FC204-218A-4C68-8157-128BDF33E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841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7C63048-DE41-174E-BB2B-ECDD25347A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143" y="0"/>
            <a:ext cx="3114675" cy="300037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91AA00A-4C29-F7EA-1403-6A2341ABFE6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23913"/>
          <a:stretch/>
        </p:blipFill>
        <p:spPr>
          <a:xfrm>
            <a:off x="4086387" y="0"/>
            <a:ext cx="3114675" cy="30003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3CD1046-473D-0DE2-538B-EEDE33FA4E1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05614" y="0"/>
            <a:ext cx="3048000" cy="300037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2E08AE9-290D-9F04-C4CF-36E45009956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3818" y="3000375"/>
            <a:ext cx="3048000" cy="300037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7177DAB-DD67-9BBA-639B-379983BD3F2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86387" y="3000375"/>
            <a:ext cx="3048000" cy="300037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BAF219D-547D-CEE7-893D-2ADB081E0C43}"/>
              </a:ext>
            </a:extLst>
          </p:cNvPr>
          <p:cNvSpPr txBox="1"/>
          <p:nvPr/>
        </p:nvSpPr>
        <p:spPr>
          <a:xfrm>
            <a:off x="436099" y="6386732"/>
            <a:ext cx="7166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le 3: Gating strategy for Figure 3D (lymphedema fluid)</a:t>
            </a:r>
          </a:p>
        </p:txBody>
      </p:sp>
    </p:spTree>
    <p:extLst>
      <p:ext uri="{BB962C8B-B14F-4D97-AF65-F5344CB8AC3E}">
        <p14:creationId xmlns:p14="http://schemas.microsoft.com/office/powerpoint/2010/main" val="15064062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E7A202E-CC9A-D17A-66A4-1BCA4A46D9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2398" y="3429000"/>
            <a:ext cx="3048000" cy="300037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D157B61-A440-79A1-6036-B1EFB33769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62808" y="239497"/>
            <a:ext cx="3048000" cy="30003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6E9468B-0C26-6F45-CEE9-E425114F872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9980" y="3429000"/>
            <a:ext cx="3048000" cy="300037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205C79E-53AF-B5A0-0912-0D48128117D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65723" y="239498"/>
            <a:ext cx="3114675" cy="300037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E556915-5C0B-7079-4A2B-FBC104DE8D7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3305" y="239496"/>
            <a:ext cx="3114675" cy="300037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647595D-1356-FA8A-2A0B-F385EC2A28C2}"/>
              </a:ext>
            </a:extLst>
          </p:cNvPr>
          <p:cNvSpPr txBox="1"/>
          <p:nvPr/>
        </p:nvSpPr>
        <p:spPr>
          <a:xfrm>
            <a:off x="409980" y="6488668"/>
            <a:ext cx="5940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le </a:t>
            </a:r>
            <a:r>
              <a:rPr lang="en-US" dirty="0"/>
              <a:t>3: Gating strategy for Figure 3D (blood)</a:t>
            </a:r>
          </a:p>
        </p:txBody>
      </p:sp>
    </p:spTree>
    <p:extLst>
      <p:ext uri="{BB962C8B-B14F-4D97-AF65-F5344CB8AC3E}">
        <p14:creationId xmlns:p14="http://schemas.microsoft.com/office/powerpoint/2010/main" val="620373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34</Words>
  <Application>Microsoft Office PowerPoint</Application>
  <PresentationFormat>Widescreen</PresentationFormat>
  <Paragraphs>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>MS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mpbell, Adana-Christine</dc:creator>
  <cp:lastModifiedBy>Stull-Lane, Annica</cp:lastModifiedBy>
  <cp:revision>5</cp:revision>
  <dcterms:created xsi:type="dcterms:W3CDTF">2025-06-23T01:04:32Z</dcterms:created>
  <dcterms:modified xsi:type="dcterms:W3CDTF">2025-07-10T18:22:32Z</dcterms:modified>
</cp:coreProperties>
</file>